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8" autoAdjust="0"/>
    <p:restoredTop sz="94660"/>
  </p:normalViewPr>
  <p:slideViewPr>
    <p:cSldViewPr snapToGrid="0">
      <p:cViewPr varScale="1">
        <p:scale>
          <a:sx n="70" d="100"/>
          <a:sy n="70" d="100"/>
        </p:scale>
        <p:origin x="654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69B4EE-76D3-41D3-BD3B-3E7530E59D2B}" type="datetimeFigureOut">
              <a:rPr lang="en-CA" smtClean="0"/>
              <a:t>2021-09-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BFCC1-E19B-4F05-BD07-6EAA806F8E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2078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69B4EE-76D3-41D3-BD3B-3E7530E59D2B}" type="datetimeFigureOut">
              <a:rPr lang="en-CA" smtClean="0"/>
              <a:t>2021-09-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BFCC1-E19B-4F05-BD07-6EAA806F8E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525639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69B4EE-76D3-41D3-BD3B-3E7530E59D2B}" type="datetimeFigureOut">
              <a:rPr lang="en-CA" smtClean="0"/>
              <a:t>2021-09-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BFCC1-E19B-4F05-BD07-6EAA806F8E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559513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69B4EE-76D3-41D3-BD3B-3E7530E59D2B}" type="datetimeFigureOut">
              <a:rPr lang="en-CA" smtClean="0"/>
              <a:t>2021-09-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BFCC1-E19B-4F05-BD07-6EAA806F8E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504607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69B4EE-76D3-41D3-BD3B-3E7530E59D2B}" type="datetimeFigureOut">
              <a:rPr lang="en-CA" smtClean="0"/>
              <a:t>2021-09-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BFCC1-E19B-4F05-BD07-6EAA806F8E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600917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69B4EE-76D3-41D3-BD3B-3E7530E59D2B}" type="datetimeFigureOut">
              <a:rPr lang="en-CA" smtClean="0"/>
              <a:t>2021-09-1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BFCC1-E19B-4F05-BD07-6EAA806F8E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412551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69B4EE-76D3-41D3-BD3B-3E7530E59D2B}" type="datetimeFigureOut">
              <a:rPr lang="en-CA" smtClean="0"/>
              <a:t>2021-09-14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BFCC1-E19B-4F05-BD07-6EAA806F8E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103547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69B4EE-76D3-41D3-BD3B-3E7530E59D2B}" type="datetimeFigureOut">
              <a:rPr lang="en-CA" smtClean="0"/>
              <a:t>2021-09-14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BFCC1-E19B-4F05-BD07-6EAA806F8E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314877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69B4EE-76D3-41D3-BD3B-3E7530E59D2B}" type="datetimeFigureOut">
              <a:rPr lang="en-CA" smtClean="0"/>
              <a:t>2021-09-14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BFCC1-E19B-4F05-BD07-6EAA806F8E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31786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69B4EE-76D3-41D3-BD3B-3E7530E59D2B}" type="datetimeFigureOut">
              <a:rPr lang="en-CA" smtClean="0"/>
              <a:t>2021-09-1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BFCC1-E19B-4F05-BD07-6EAA806F8E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905444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69B4EE-76D3-41D3-BD3B-3E7530E59D2B}" type="datetimeFigureOut">
              <a:rPr lang="en-CA" smtClean="0"/>
              <a:t>2021-09-1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ABFCC1-E19B-4F05-BD07-6EAA806F8E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734455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69B4EE-76D3-41D3-BD3B-3E7530E59D2B}" type="datetimeFigureOut">
              <a:rPr lang="en-CA" smtClean="0"/>
              <a:t>2021-09-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ABFCC1-E19B-4F05-BD07-6EAA806F8E1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503730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5390" y="558800"/>
            <a:ext cx="4810947" cy="4737577"/>
          </a:xfrm>
          <a:prstGeom prst="rect">
            <a:avLst/>
          </a:prstGeom>
        </p:spPr>
      </p:pic>
      <p:sp>
        <p:nvSpPr>
          <p:cNvPr id="6" name="Right Arrow 5"/>
          <p:cNvSpPr/>
          <p:nvPr/>
        </p:nvSpPr>
        <p:spPr>
          <a:xfrm rot="1546332">
            <a:off x="5921281" y="1247713"/>
            <a:ext cx="456041" cy="138519"/>
          </a:xfrm>
          <a:prstGeom prst="rightArrow">
            <a:avLst/>
          </a:prstGeom>
          <a:solidFill>
            <a:schemeClr val="bg2"/>
          </a:solidFill>
          <a:ln>
            <a:solidFill>
              <a:schemeClr val="bg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8" name="Right Arrow 7"/>
          <p:cNvSpPr/>
          <p:nvPr/>
        </p:nvSpPr>
        <p:spPr>
          <a:xfrm rot="15070412">
            <a:off x="6230843" y="2864586"/>
            <a:ext cx="456041" cy="138519"/>
          </a:xfrm>
          <a:prstGeom prst="rightArrow">
            <a:avLst/>
          </a:prstGeom>
          <a:solidFill>
            <a:schemeClr val="bg2"/>
          </a:solidFill>
          <a:ln>
            <a:solidFill>
              <a:schemeClr val="bg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2" name="TextBox 1"/>
          <p:cNvSpPr txBox="1"/>
          <p:nvPr/>
        </p:nvSpPr>
        <p:spPr>
          <a:xfrm>
            <a:off x="789707" y="5701088"/>
            <a:ext cx="1079862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1</a:t>
            </a:r>
            <a:r>
              <a:rPr lang="en-US" dirty="0" smtClean="0"/>
              <a:t>. </a:t>
            </a:r>
            <a:r>
              <a:rPr lang="en-CA" dirty="0"/>
              <a:t>GISH analysis of m</a:t>
            </a:r>
            <a:r>
              <a:rPr lang="en-US" dirty="0" err="1"/>
              <a:t>itotic</a:t>
            </a:r>
            <a:r>
              <a:rPr lang="en-US" dirty="0"/>
              <a:t> metaphase chromosome spread from </a:t>
            </a:r>
            <a:r>
              <a:rPr lang="en-US" dirty="0" err="1"/>
              <a:t>ditelosomic</a:t>
            </a:r>
            <a:r>
              <a:rPr lang="en-US" dirty="0"/>
              <a:t> addition line CS-7EL (2n=42 +2t).</a:t>
            </a:r>
            <a:r>
              <a:rPr lang="en-CA" dirty="0"/>
              <a:t> Fluorescently-labelled total genomic DNA from </a:t>
            </a:r>
            <a:r>
              <a:rPr lang="en-CA" i="1" dirty="0"/>
              <a:t>Th. </a:t>
            </a:r>
            <a:r>
              <a:rPr lang="en-CA" i="1" dirty="0" err="1"/>
              <a:t>elongatum</a:t>
            </a:r>
            <a:r>
              <a:rPr lang="en-CA" dirty="0"/>
              <a:t> was use for hybridization. </a:t>
            </a:r>
            <a:r>
              <a:rPr lang="en-US" dirty="0" err="1"/>
              <a:t>Telosomes</a:t>
            </a:r>
            <a:r>
              <a:rPr lang="en-US" dirty="0"/>
              <a:t> 7EL are labelled by arrows. 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3105219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4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erese</dc:creator>
  <cp:lastModifiedBy>Ouellet, Thérèse</cp:lastModifiedBy>
  <cp:revision>6</cp:revision>
  <dcterms:created xsi:type="dcterms:W3CDTF">2021-02-18T20:21:17Z</dcterms:created>
  <dcterms:modified xsi:type="dcterms:W3CDTF">2021-09-14T14:58:23Z</dcterms:modified>
</cp:coreProperties>
</file>